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26" d="100"/>
          <a:sy n="126" d="100"/>
        </p:scale>
        <p:origin x="-402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2A9F09-5C28-4EC6-A215-C89274431EA4}" type="datetimeFigureOut">
              <a:rPr lang="en-US" smtClean="0"/>
              <a:t>11/1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0F56A8-AB6A-4ED4-956A-22D633B07D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59069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2A9F09-5C28-4EC6-A215-C89274431EA4}" type="datetimeFigureOut">
              <a:rPr lang="en-US" smtClean="0"/>
              <a:t>11/1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0F56A8-AB6A-4ED4-956A-22D633B07D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23106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2A9F09-5C28-4EC6-A215-C89274431EA4}" type="datetimeFigureOut">
              <a:rPr lang="en-US" smtClean="0"/>
              <a:t>11/1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0F56A8-AB6A-4ED4-956A-22D633B07D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3485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2A9F09-5C28-4EC6-A215-C89274431EA4}" type="datetimeFigureOut">
              <a:rPr lang="en-US" smtClean="0"/>
              <a:t>11/1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0F56A8-AB6A-4ED4-956A-22D633B07D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66645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2A9F09-5C28-4EC6-A215-C89274431EA4}" type="datetimeFigureOut">
              <a:rPr lang="en-US" smtClean="0"/>
              <a:t>11/1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0F56A8-AB6A-4ED4-956A-22D633B07D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78258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2A9F09-5C28-4EC6-A215-C89274431EA4}" type="datetimeFigureOut">
              <a:rPr lang="en-US" smtClean="0"/>
              <a:t>11/15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0F56A8-AB6A-4ED4-956A-22D633B07D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5866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2A9F09-5C28-4EC6-A215-C89274431EA4}" type="datetimeFigureOut">
              <a:rPr lang="en-US" smtClean="0"/>
              <a:t>11/15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0F56A8-AB6A-4ED4-956A-22D633B07D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56118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2A9F09-5C28-4EC6-A215-C89274431EA4}" type="datetimeFigureOut">
              <a:rPr lang="en-US" smtClean="0"/>
              <a:t>11/15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0F56A8-AB6A-4ED4-956A-22D633B07D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25973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2A9F09-5C28-4EC6-A215-C89274431EA4}" type="datetimeFigureOut">
              <a:rPr lang="en-US" smtClean="0"/>
              <a:t>11/15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0F56A8-AB6A-4ED4-956A-22D633B07D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14982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2A9F09-5C28-4EC6-A215-C89274431EA4}" type="datetimeFigureOut">
              <a:rPr lang="en-US" smtClean="0"/>
              <a:t>11/15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0F56A8-AB6A-4ED4-956A-22D633B07D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29242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2A9F09-5C28-4EC6-A215-C89274431EA4}" type="datetimeFigureOut">
              <a:rPr lang="en-US" smtClean="0"/>
              <a:t>11/15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0F56A8-AB6A-4ED4-956A-22D633B07D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14802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2A9F09-5C28-4EC6-A215-C89274431EA4}" type="datetimeFigureOut">
              <a:rPr lang="en-US" smtClean="0"/>
              <a:t>11/1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0F56A8-AB6A-4ED4-956A-22D633B07D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24890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94595245"/>
              </p:ext>
            </p:extLst>
          </p:nvPr>
        </p:nvGraphicFramePr>
        <p:xfrm>
          <a:off x="647565" y="1145042"/>
          <a:ext cx="7920879" cy="4876690"/>
        </p:xfrm>
        <a:graphic>
          <a:graphicData uri="http://schemas.openxmlformats.org/drawingml/2006/table">
            <a:tbl>
              <a:tblPr firstRow="1" firstCol="1" lastRow="1" lastCol="1" bandRow="1" bandCol="1"/>
              <a:tblGrid>
                <a:gridCol w="843095"/>
                <a:gridCol w="996111"/>
                <a:gridCol w="689477"/>
                <a:gridCol w="766285"/>
                <a:gridCol w="707477"/>
                <a:gridCol w="1173130"/>
                <a:gridCol w="759084"/>
                <a:gridCol w="759084"/>
                <a:gridCol w="1227136"/>
              </a:tblGrid>
              <a:tr h="251460">
                <a:tc rowSpan="2"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100" dirty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SNP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65558" marR="655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cohort (n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65558" marR="655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4"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                      genotype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65558" marR="655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               allele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65558" marR="655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06599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A/A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  <a:p>
                      <a:pPr algn="just">
                        <a:lnSpc>
                          <a:spcPct val="15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n (%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65558" marR="655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A/a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  <a:p>
                      <a:pPr algn="just">
                        <a:lnSpc>
                          <a:spcPct val="15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n (%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65558" marR="655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a/a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  <a:p>
                      <a:pPr algn="just">
                        <a:lnSpc>
                          <a:spcPct val="15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n (%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65558" marR="655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recessive model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  <a:p>
                      <a:pPr algn="just">
                        <a:lnSpc>
                          <a:spcPct val="150000"/>
                        </a:lnSpc>
                        <a:spcBef>
                          <a:spcPts val="800"/>
                        </a:spcBef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p value *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OR (ci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65558" marR="655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A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  <a:p>
                      <a:pPr algn="just">
                        <a:lnSpc>
                          <a:spcPct val="15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n (%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65558" marR="655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a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  <a:p>
                      <a:pPr algn="just">
                        <a:lnSpc>
                          <a:spcPct val="15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n (%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65558" marR="655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recessive model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  <a:p>
                      <a:pPr algn="just">
                        <a:lnSpc>
                          <a:spcPct val="150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p value *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OR (ci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65558" marR="655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72840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100" i="1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rs651724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  <a:p>
                      <a:pPr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T&gt;A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65558" marR="655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100" dirty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cases (262)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  <a:p>
                      <a:pPr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100" dirty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controls (493)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65558" marR="655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143 (55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  <a:p>
                      <a:pPr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248 (50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65558" marR="655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98 (37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  <a:p>
                      <a:pPr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205 (42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65558" marR="655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21 (8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  <a:p>
                      <a:pPr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40 (8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65558" marR="655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0.26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  <a:p>
                      <a:pPr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0.84 [0.62-1.13]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65558" marR="655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384 (73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  <a:p>
                      <a:pPr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701 (71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65558" marR="655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140 (27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  <a:p>
                      <a:pPr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285 (29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65558" marR="655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0.37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  <a:p>
                      <a:pPr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0.89 [0. 7-1.13]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65558" marR="655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72840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100" i="1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rs35174018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  <a:p>
                      <a:pPr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C&gt;T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65558" marR="655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cases (275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  <a:p>
                      <a:pPr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controls (495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65558" marR="655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239 (87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  <a:p>
                      <a:pPr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421 (85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65558" marR="655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35 (13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  <a:p>
                      <a:pPr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69 (14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65558" marR="655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1 (0.4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  <a:p>
                      <a:pPr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5 (1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65558" marR="655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0.48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  <a:p>
                      <a:pPr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0.85 [0.55-1.31]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65558" marR="655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513 (93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  <a:p>
                      <a:pPr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911 (92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65558" marR="655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37 (7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  <a:p>
                      <a:pPr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79 (8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65558" marR="655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0.37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  <a:p>
                      <a:pPr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0.83 [0. 55-1.24]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65558" marR="655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72840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100" i="1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rs3743123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  <a:p>
                      <a:pPr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C&gt;T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65558" marR="655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cases (299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  <a:p>
                      <a:pPr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controls (500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65558" marR="655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141 (47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  <a:p>
                      <a:pPr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275 (55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65558" marR="655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124 (41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  <a:p>
                      <a:pPr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180 (36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65558" marR="655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100" dirty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34 (11)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  <a:p>
                      <a:pPr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100" dirty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45 (9)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65558" marR="655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100" b="1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0.03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  <a:p>
                      <a:pPr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1.36 [1.02-1.82]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65558" marR="655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406 (68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  <a:p>
                      <a:pPr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730 (73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65558" marR="655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192 (32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  <a:p>
                      <a:pPr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270 (27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65558" marR="655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100" b="1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0.03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  <a:p>
                      <a:pPr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1.28 [1.02-1.59]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65558" marR="655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72840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100" i="1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rs34964522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  <a:p>
                      <a:pPr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G&gt;A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65558" marR="655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100" dirty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cases (298)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  <a:p>
                      <a:pPr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100" dirty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controls (499)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65558" marR="655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236 (81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  <a:p>
                      <a:pPr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401 (80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65558" marR="655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54 (17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  <a:p>
                      <a:pPr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91 (18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65558" marR="655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8 (2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  <a:p>
                      <a:pPr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7 (1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65558" marR="655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0.691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  <a:p>
                      <a:pPr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1.07 [0.75-1.53]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65558" marR="655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526 (88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  <a:p>
                      <a:pPr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893 (89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65558" marR="655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70 (12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  <a:p>
                      <a:pPr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105 (10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65558" marR="655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100" dirty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0.45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  <a:p>
                      <a:pPr algn="just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100" dirty="0"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1.13 [0.82-1.56]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65558" marR="6555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7" name="Rectangle 6"/>
          <p:cNvSpPr/>
          <p:nvPr/>
        </p:nvSpPr>
        <p:spPr>
          <a:xfrm>
            <a:off x="1320418" y="481244"/>
            <a:ext cx="6575172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100" b="1" smtClean="0">
                <a:latin typeface="Arial" panose="020B0604020202020204" pitchFamily="34" charset="0"/>
                <a:cs typeface="Arial" panose="020B0604020202020204" pitchFamily="34" charset="0"/>
              </a:rPr>
              <a:t>S4 </a:t>
            </a:r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able. Case-control </a:t>
            </a: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association studies of 4 SNPs in</a:t>
            </a:r>
            <a:r>
              <a:rPr lang="en-GB" sz="1100" b="1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exon 2 of </a:t>
            </a:r>
            <a:r>
              <a:rPr lang="en-GB" sz="1100" b="1" i="1" dirty="0">
                <a:latin typeface="Arial" panose="020B0604020202020204" pitchFamily="34" charset="0"/>
                <a:cs typeface="Arial" panose="020B0604020202020204" pitchFamily="34" charset="0"/>
              </a:rPr>
              <a:t>GJD2 </a:t>
            </a: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in the </a:t>
            </a:r>
            <a:r>
              <a:rPr lang="en-GB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CoLaus</a:t>
            </a: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 study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Rectangle 7"/>
          <p:cNvSpPr/>
          <p:nvPr/>
        </p:nvSpPr>
        <p:spPr>
          <a:xfrm>
            <a:off x="611560" y="5997188"/>
            <a:ext cx="7992888" cy="6001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Case = T2D patients; control = </a:t>
            </a:r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normoglycemic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individuals; A = major allele; a = minor allele; OR = odd ratio; ci = 95% confidence interval; n = case number; % = percent value. The 4 SNPs are in Hardy-Weinberg equilibrium in all groups (p&gt;0.05). * Distributions and OR values were compared by a Pearson chi square test.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686740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373</Words>
  <Application>Microsoft Office PowerPoint</Application>
  <PresentationFormat>On-screen Show (4:3)</PresentationFormat>
  <Paragraphs>9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é de Genèv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alentina</dc:creator>
  <cp:lastModifiedBy>Valentina</cp:lastModifiedBy>
  <cp:revision>12</cp:revision>
  <dcterms:created xsi:type="dcterms:W3CDTF">2015-03-29T16:30:26Z</dcterms:created>
  <dcterms:modified xsi:type="dcterms:W3CDTF">2015-11-15T16:31:46Z</dcterms:modified>
</cp:coreProperties>
</file>